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583363" cy="89614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50" d="100"/>
          <a:sy n="50" d="100"/>
        </p:scale>
        <p:origin x="-1398" y="-114"/>
      </p:cViewPr>
      <p:guideLst>
        <p:guide orient="horz" pos="2823"/>
        <p:guide pos="207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01A369-0A5B-4BFE-B090-7FD50303C5A8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70113" y="685800"/>
            <a:ext cx="25177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662696-E9AF-447E-B6BB-096B6F0E7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0431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70113" y="685800"/>
            <a:ext cx="25177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662696-E9AF-447E-B6BB-096B6F0E715D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3753" y="2783858"/>
            <a:ext cx="5595858" cy="192090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7506" y="5078149"/>
            <a:ext cx="4608354" cy="22901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579704" y="479189"/>
            <a:ext cx="1110943" cy="101936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6876" y="479189"/>
            <a:ext cx="3223106" cy="101936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041" y="5758555"/>
            <a:ext cx="5595858" cy="177984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041" y="3798242"/>
            <a:ext cx="5595858" cy="196031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6876" y="2788004"/>
            <a:ext cx="2167024" cy="788482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23623" y="2788004"/>
            <a:ext cx="2167024" cy="788482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68" y="358874"/>
            <a:ext cx="5925027" cy="1493573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8" y="2005952"/>
            <a:ext cx="2908796" cy="8359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168" y="2841937"/>
            <a:ext cx="2908796" cy="51632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44258" y="2005952"/>
            <a:ext cx="2909938" cy="8359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44258" y="2841937"/>
            <a:ext cx="2909938" cy="51632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71" y="356798"/>
            <a:ext cx="2165881" cy="151846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3912" y="356801"/>
            <a:ext cx="3680284" cy="764833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9171" y="1875265"/>
            <a:ext cx="2165881" cy="612987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0386" y="6273008"/>
            <a:ext cx="3950018" cy="74056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90386" y="800722"/>
            <a:ext cx="3950018" cy="53768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90386" y="7013573"/>
            <a:ext cx="3950018" cy="10517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9168" y="358874"/>
            <a:ext cx="5925027" cy="14935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8" y="2091005"/>
            <a:ext cx="5925027" cy="59141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9168" y="8305929"/>
            <a:ext cx="1536118" cy="4771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4317C-49A3-45CA-92A1-94F98D1FC339}" type="datetimeFigureOut">
              <a:rPr lang="en-US" smtClean="0"/>
              <a:t>8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49317" y="8305929"/>
            <a:ext cx="2084732" cy="4771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8077" y="8305929"/>
            <a:ext cx="1536118" cy="47711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C7E8B1-1801-4398-A6CC-8FE82D398DF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5" name="Group 134"/>
          <p:cNvGrpSpPr/>
          <p:nvPr/>
        </p:nvGrpSpPr>
        <p:grpSpPr>
          <a:xfrm>
            <a:off x="213519" y="153138"/>
            <a:ext cx="6172200" cy="8759449"/>
            <a:chOff x="342900" y="76938"/>
            <a:chExt cx="6172200" cy="8759449"/>
          </a:xfrm>
        </p:grpSpPr>
        <p:grpSp>
          <p:nvGrpSpPr>
            <p:cNvPr id="136" name="Group 135"/>
            <p:cNvGrpSpPr/>
            <p:nvPr/>
          </p:nvGrpSpPr>
          <p:grpSpPr>
            <a:xfrm>
              <a:off x="428122" y="76938"/>
              <a:ext cx="2543678" cy="6525399"/>
              <a:chOff x="562303" y="76938"/>
              <a:chExt cx="2543678" cy="6525399"/>
            </a:xfrm>
          </p:grpSpPr>
          <p:sp>
            <p:nvSpPr>
              <p:cNvPr id="158" name="Text Box 11"/>
              <p:cNvSpPr txBox="1">
                <a:spLocks noChangeArrowheads="1"/>
              </p:cNvSpPr>
              <p:nvPr/>
            </p:nvSpPr>
            <p:spPr bwMode="auto">
              <a:xfrm>
                <a:off x="994506" y="76938"/>
                <a:ext cx="211147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b="1" u="sng" dirty="0" smtClean="0">
                    <a:latin typeface="Arial" pitchFamily="34" charset="0"/>
                    <a:cs typeface="Arial" pitchFamily="34" charset="0"/>
                  </a:rPr>
                  <a:t>Segregating amplification </a:t>
                </a:r>
                <a:endParaRPr lang="en-US" sz="1200" b="1" u="sng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 Box 2"/>
              <p:cNvSpPr txBox="1">
                <a:spLocks noChangeArrowheads="1"/>
              </p:cNvSpPr>
              <p:nvPr/>
            </p:nvSpPr>
            <p:spPr bwMode="auto">
              <a:xfrm>
                <a:off x="562303" y="76938"/>
                <a:ext cx="535372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A</a:t>
                </a:r>
              </a:p>
            </p:txBody>
          </p:sp>
          <p:sp>
            <p:nvSpPr>
              <p:cNvPr id="160" name="Text Box 11"/>
              <p:cNvSpPr txBox="1">
                <a:spLocks noChangeArrowheads="1"/>
              </p:cNvSpPr>
              <p:nvPr/>
            </p:nvSpPr>
            <p:spPr bwMode="auto">
              <a:xfrm>
                <a:off x="1515094" y="6325338"/>
                <a:ext cx="854721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Ratio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61" name="Picture 5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b="2778"/>
              <a:stretch>
                <a:fillRect/>
              </a:stretch>
            </p:blipFill>
            <p:spPr bwMode="auto">
              <a:xfrm>
                <a:off x="1017269" y="2480924"/>
                <a:ext cx="1877623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2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52163" y="3101837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Text Box 11"/>
              <p:cNvSpPr txBox="1">
                <a:spLocks noChangeArrowheads="1"/>
              </p:cNvSpPr>
              <p:nvPr/>
            </p:nvSpPr>
            <p:spPr bwMode="auto">
              <a:xfrm>
                <a:off x="1478675" y="4109823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98295" y="3228900"/>
                <a:ext cx="1434688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 2    4     6     8    1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65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019355" y="518898"/>
                <a:ext cx="1846154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6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52163" y="1155051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Text Box 11"/>
              <p:cNvSpPr txBox="1">
                <a:spLocks noChangeArrowheads="1"/>
              </p:cNvSpPr>
              <p:nvPr/>
            </p:nvSpPr>
            <p:spPr bwMode="auto">
              <a:xfrm>
                <a:off x="1402475" y="409539"/>
                <a:ext cx="109036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d2 vs. HB3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8" name="Text Box 11"/>
              <p:cNvSpPr txBox="1">
                <a:spLocks noChangeArrowheads="1"/>
              </p:cNvSpPr>
              <p:nvPr/>
            </p:nvSpPr>
            <p:spPr bwMode="auto">
              <a:xfrm>
                <a:off x="1478675" y="2127414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90156" y="1235316"/>
                <a:ext cx="1476366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2   4    6    8   10  12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Text Box 11"/>
              <p:cNvSpPr txBox="1">
                <a:spLocks noChangeArrowheads="1"/>
              </p:cNvSpPr>
              <p:nvPr/>
            </p:nvSpPr>
            <p:spPr bwMode="auto">
              <a:xfrm>
                <a:off x="1402475" y="2418035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71" name="Picture 2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415"/>
              <a:stretch>
                <a:fillRect/>
              </a:stretch>
            </p:blipFill>
            <p:spPr bwMode="auto">
              <a:xfrm>
                <a:off x="1067080" y="4384152"/>
                <a:ext cx="1778000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2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52163" y="5086440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Text Box 11"/>
              <p:cNvSpPr txBox="1">
                <a:spLocks noChangeArrowheads="1"/>
              </p:cNvSpPr>
              <p:nvPr/>
            </p:nvSpPr>
            <p:spPr bwMode="auto">
              <a:xfrm>
                <a:off x="1390600" y="6001178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416926" y="5108347"/>
                <a:ext cx="1477969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2   4   8   10   12   14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5" name="Text Box 11"/>
              <p:cNvSpPr txBox="1">
                <a:spLocks noChangeArrowheads="1"/>
              </p:cNvSpPr>
              <p:nvPr/>
            </p:nvSpPr>
            <p:spPr bwMode="auto">
              <a:xfrm>
                <a:off x="1402474" y="4344138"/>
                <a:ext cx="761999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76" name="Straight Connector 175"/>
              <p:cNvCxnSpPr/>
              <p:nvPr/>
            </p:nvCxnSpPr>
            <p:spPr bwMode="auto">
              <a:xfrm rot="5400000" flipH="1" flipV="1">
                <a:off x="-270414" y="3231617"/>
                <a:ext cx="5120641" cy="1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136"/>
            <p:cNvGrpSpPr/>
            <p:nvPr/>
          </p:nvGrpSpPr>
          <p:grpSpPr>
            <a:xfrm>
              <a:off x="3886200" y="76938"/>
              <a:ext cx="2250585" cy="6525399"/>
              <a:chOff x="3530386" y="76938"/>
              <a:chExt cx="2250585" cy="6525399"/>
            </a:xfrm>
          </p:grpSpPr>
          <p:sp>
            <p:nvSpPr>
              <p:cNvPr id="139" name="Text Box 14"/>
              <p:cNvSpPr txBox="1">
                <a:spLocks noChangeArrowheads="1"/>
              </p:cNvSpPr>
              <p:nvPr/>
            </p:nvSpPr>
            <p:spPr bwMode="auto">
              <a:xfrm>
                <a:off x="3994905" y="76938"/>
                <a:ext cx="178606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b="1" i="1" u="sng" dirty="0" smtClean="0">
                    <a:latin typeface="Arial" pitchFamily="34" charset="0"/>
                    <a:cs typeface="Arial" pitchFamily="34" charset="0"/>
                  </a:rPr>
                  <a:t>De novo</a:t>
                </a:r>
                <a:r>
                  <a:rPr lang="en-US" sz="1200" b="1" u="sng" dirty="0" smtClean="0">
                    <a:latin typeface="Arial" pitchFamily="34" charset="0"/>
                    <a:cs typeface="Arial" pitchFamily="34" charset="0"/>
                  </a:rPr>
                  <a:t> amplification</a:t>
                </a:r>
                <a:endParaRPr lang="en-US" sz="1200" b="1" u="sng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Text Box 2"/>
              <p:cNvSpPr txBox="1">
                <a:spLocks noChangeArrowheads="1"/>
              </p:cNvSpPr>
              <p:nvPr/>
            </p:nvSpPr>
            <p:spPr bwMode="auto">
              <a:xfrm>
                <a:off x="3552466" y="76938"/>
                <a:ext cx="440809" cy="276999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ts val="100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rPr>
                  <a:t>B</a:t>
                </a:r>
              </a:p>
            </p:txBody>
          </p:sp>
          <p:sp>
            <p:nvSpPr>
              <p:cNvPr id="141" name="Text Box 11"/>
              <p:cNvSpPr txBox="1">
                <a:spLocks noChangeArrowheads="1"/>
              </p:cNvSpPr>
              <p:nvPr/>
            </p:nvSpPr>
            <p:spPr bwMode="auto">
              <a:xfrm>
                <a:off x="4679075" y="6325338"/>
                <a:ext cx="854721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Log</a:t>
                </a:r>
                <a:r>
                  <a:rPr lang="en-US" sz="1200" baseline="-25000" dirty="0" smtClean="0">
                    <a:latin typeface="Arial" pitchFamily="34" charset="0"/>
                    <a:cs typeface="Arial" pitchFamily="34" charset="0"/>
                  </a:rPr>
                  <a:t>2</a:t>
                </a:r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Ratio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42" name="Picture 11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918207" y="2480924"/>
                <a:ext cx="1791198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3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14275" y="3183211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Text Box 11"/>
              <p:cNvSpPr txBox="1">
                <a:spLocks noChangeArrowheads="1"/>
              </p:cNvSpPr>
              <p:nvPr/>
            </p:nvSpPr>
            <p:spPr bwMode="auto">
              <a:xfrm>
                <a:off x="4311354" y="4104875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355347" y="3259047"/>
                <a:ext cx="1322478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  20    40    60    8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46" name="Picture 1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3875787" y="518898"/>
                <a:ext cx="1876038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7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14274" y="1231251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8" name="Text Box 11"/>
              <p:cNvSpPr txBox="1">
                <a:spLocks noChangeArrowheads="1"/>
              </p:cNvSpPr>
              <p:nvPr/>
            </p:nvSpPr>
            <p:spPr bwMode="auto">
              <a:xfrm>
                <a:off x="4268624" y="409539"/>
                <a:ext cx="109036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Dd2 vs. HB3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9" name="Text Box 11"/>
              <p:cNvSpPr txBox="1">
                <a:spLocks noChangeArrowheads="1"/>
              </p:cNvSpPr>
              <p:nvPr/>
            </p:nvSpPr>
            <p:spPr bwMode="auto">
              <a:xfrm>
                <a:off x="4311353" y="2122463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189723" y="1180165"/>
                <a:ext cx="1562928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50  100  150  200  25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1" name="Text Box 11"/>
              <p:cNvSpPr txBox="1">
                <a:spLocks noChangeArrowheads="1"/>
              </p:cNvSpPr>
              <p:nvPr/>
            </p:nvSpPr>
            <p:spPr bwMode="auto">
              <a:xfrm>
                <a:off x="4268625" y="2418035"/>
                <a:ext cx="798617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 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52" name="Picture 10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889779" y="4384152"/>
                <a:ext cx="1778093" cy="182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3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14274" y="4934040"/>
                <a:ext cx="909223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Frequenc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Text Box 11"/>
              <p:cNvSpPr txBox="1">
                <a:spLocks noChangeArrowheads="1"/>
              </p:cNvSpPr>
              <p:nvPr/>
            </p:nvSpPr>
            <p:spPr bwMode="auto">
              <a:xfrm>
                <a:off x="4311353" y="5996227"/>
                <a:ext cx="1322798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-4      -2      0      2 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5" name="Text Box 11"/>
              <p:cNvSpPr txBox="1">
                <a:spLocks noChangeArrowheads="1"/>
              </p:cNvSpPr>
              <p:nvPr/>
            </p:nvSpPr>
            <p:spPr bwMode="auto">
              <a:xfrm rot="16200000">
                <a:off x="3243446" y="5086075"/>
                <a:ext cx="1482778" cy="169277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100" dirty="0" smtClean="0">
                    <a:latin typeface="Arial" pitchFamily="34" charset="0"/>
                    <a:cs typeface="Arial" pitchFamily="34" charset="0"/>
                  </a:rPr>
                  <a:t>0  20  30  40  50  60  70</a:t>
                </a:r>
                <a:endParaRPr lang="en-US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Text Box 11"/>
              <p:cNvSpPr txBox="1">
                <a:spLocks noChangeArrowheads="1"/>
              </p:cNvSpPr>
              <p:nvPr/>
            </p:nvSpPr>
            <p:spPr bwMode="auto">
              <a:xfrm>
                <a:off x="4268624" y="4344138"/>
                <a:ext cx="761999" cy="276999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Progeny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57" name="Straight Connector 17"/>
              <p:cNvCxnSpPr/>
              <p:nvPr/>
            </p:nvCxnSpPr>
            <p:spPr bwMode="auto">
              <a:xfrm rot="5400000" flipH="1" flipV="1">
                <a:off x="2575954" y="3246858"/>
                <a:ext cx="5120641" cy="1"/>
              </a:xfrm>
              <a:prstGeom prst="line">
                <a:avLst/>
              </a:prstGeom>
              <a:ln w="19050">
                <a:solidFill>
                  <a:srgbClr val="FF00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8" name="Rectangle 1"/>
            <p:cNvSpPr>
              <a:spLocks noChangeArrowheads="1"/>
            </p:cNvSpPr>
            <p:nvPr/>
          </p:nvSpPr>
          <p:spPr bwMode="auto">
            <a:xfrm>
              <a:off x="342900" y="6428096"/>
              <a:ext cx="6172200" cy="2408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0" tIns="152352" rIns="0" bIns="38088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Additional file 4  – Hybridization signal distribution in segregating and </a:t>
              </a:r>
              <a:r>
                <a:rPr kumimoji="0" lang="en-GB" sz="12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de novo</a:t>
              </a:r>
              <a:r>
                <a:rPr kumimoji="0" lang="en-GB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Times New Roman" pitchFamily="18" charset="0"/>
                  <a:cs typeface="Times New Roman" pitchFamily="18" charset="0"/>
                </a:rPr>
                <a:t> amplifications.</a:t>
              </a:r>
              <a:endParaRPr kumimoji="0" lang="en-GB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endParaRPr>
            </a:p>
            <a:p>
              <a:pPr lvl="0" eaLnBrk="0" fontAlgn="base" hangingPunct="0">
                <a:lnSpc>
                  <a:spcPct val="2000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e distribution of the log</a:t>
              </a:r>
              <a:r>
                <a:rPr kumimoji="0" lang="en-US" altLang="zh-CN" sz="1200" b="0" i="0" u="none" strike="noStrike" cap="none" normalizeH="0" baseline="-3000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2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ratio of the</a:t>
              </a:r>
              <a:r>
                <a:rPr kumimoji="0" lang="en-US" altLang="zh-CN" sz="12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progeny hybridization signals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at segregating and </a:t>
              </a:r>
              <a:r>
                <a:rPr kumimoji="0" lang="en-US" altLang="zh-CN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 novo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CNV regions were assessed in comparison with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at</a:t>
              </a:r>
              <a:r>
                <a:rPr kumimoji="0" lang="en-US" altLang="zh-CN" sz="12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of th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e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parental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signal (Dd2/HB3). 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The positively skewed signal distribution highlights duplicated CNV regions. The clear absence of skewed signal in the Dd2/HB3 parental hybridization compared to that of the positively skewed signal distribution in progeny enabled the identification of </a:t>
              </a:r>
              <a:r>
                <a:rPr kumimoji="0" lang="en-US" altLang="zh-CN" sz="1200" b="0" i="1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de novo</a:t>
              </a:r>
              <a:r>
                <a:rPr kumimoji="0" lang="en-US" altLang="zh-CN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Calibri" pitchFamily="34" charset="0"/>
                  <a:cs typeface="Times New Roman" pitchFamily="18" charset="0"/>
                </a:rPr>
                <a:t> amplifications.  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86</Words>
  <Application>Microsoft Office PowerPoint</Application>
  <PresentationFormat>Custom</PresentationFormat>
  <Paragraphs>3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</cp:lastModifiedBy>
  <cp:revision>2</cp:revision>
  <dcterms:created xsi:type="dcterms:W3CDTF">2011-07-04T05:13:49Z</dcterms:created>
  <dcterms:modified xsi:type="dcterms:W3CDTF">2011-08-09T18:28:47Z</dcterms:modified>
</cp:coreProperties>
</file>